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9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429539" y="1063571"/>
            <a:ext cx="4027498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l Table S4: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Summary of TMB ranges per cohort and MSI. The median and interquartile range of TMB is shown per group within the cohorts, grouped by MSI status.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4DBDF061-3EF0-CB44-B215-F3B4EA279AE1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507073"/>
          <a:ext cx="4207404" cy="20320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826508">
                  <a:extLst>
                    <a:ext uri="{9D8B030D-6E8A-4147-A177-3AD203B41FA5}">
                      <a16:colId xmlns:a16="http://schemas.microsoft.com/office/drawing/2014/main" val="599413429"/>
                    </a:ext>
                  </a:extLst>
                </a:gridCol>
                <a:gridCol w="1121172">
                  <a:extLst>
                    <a:ext uri="{9D8B030D-6E8A-4147-A177-3AD203B41FA5}">
                      <a16:colId xmlns:a16="http://schemas.microsoft.com/office/drawing/2014/main" val="2836446136"/>
                    </a:ext>
                  </a:extLst>
                </a:gridCol>
                <a:gridCol w="531844">
                  <a:extLst>
                    <a:ext uri="{9D8B030D-6E8A-4147-A177-3AD203B41FA5}">
                      <a16:colId xmlns:a16="http://schemas.microsoft.com/office/drawing/2014/main" val="2368947379"/>
                    </a:ext>
                  </a:extLst>
                </a:gridCol>
                <a:gridCol w="1727880">
                  <a:extLst>
                    <a:ext uri="{9D8B030D-6E8A-4147-A177-3AD203B41FA5}">
                      <a16:colId xmlns:a16="http://schemas.microsoft.com/office/drawing/2014/main" val="2830838081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ohor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TMB (IQR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2201144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MSI unknow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.7 (0 - 3.8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2423885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-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6 (29.4 - 48.4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830244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8 (2.5 - 6.3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6431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MSI unknow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.7 (0.9 - 4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2021397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-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4.8 (21.7 - 41.3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059770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8 (2.5 - 6.3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061067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 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.3 (1.3 - 2.8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45932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-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4.9 (27.8 - 38.2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099715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8 (2.5 - 6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500112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5968972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25</Words>
  <Application>Microsoft Macintosh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6</cp:revision>
  <dcterms:created xsi:type="dcterms:W3CDTF">2022-06-12T16:24:02Z</dcterms:created>
  <dcterms:modified xsi:type="dcterms:W3CDTF">2022-06-27T19:54:39Z</dcterms:modified>
</cp:coreProperties>
</file>